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4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846" autoAdjust="0"/>
    <p:restoredTop sz="94694"/>
  </p:normalViewPr>
  <p:slideViewPr>
    <p:cSldViewPr snapToGrid="0">
      <p:cViewPr varScale="1">
        <p:scale>
          <a:sx n="117" d="100"/>
          <a:sy n="117" d="100"/>
        </p:scale>
        <p:origin x="1112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2EA442F-0254-41DF-BA0B-5FAA6BF28180}" type="datetimeFigureOut">
              <a:rPr lang="en-US" smtClean="0"/>
              <a:t>8/28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119990B-E2FE-4908-8E37-DB246F82A7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51248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119990B-E2FE-4908-8E37-DB246F82A78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08036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905DFE-0EF5-7353-AB12-10D1053FDA5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EFB5106-701D-0D7E-7FAF-A70CBBA63C9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36C95D-820A-82ED-DF47-64B0BB21B4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604DFE-CF3E-4541-8F0B-F3494D36DCC7}" type="datetimeFigureOut">
              <a:rPr lang="en-US" smtClean="0"/>
              <a:t>8/2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9FDD50-8ADF-6301-7426-046E9ACC29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742A73-C643-89F1-01F8-37E1D6658D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9EB07-91D4-47CA-83EB-E8AEF24BB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36263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21B704-BBB0-E46A-BEEE-CC0B4CA1AA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69DC728-0165-D350-87FB-16F55F8CCE8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EEC772-1C3F-1701-29D7-A514B07472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604DFE-CF3E-4541-8F0B-F3494D36DCC7}" type="datetimeFigureOut">
              <a:rPr lang="en-US" smtClean="0"/>
              <a:t>8/2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E2671C-784C-B5FC-84E2-CF92C256F8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AEE9AD-23D4-74BF-68E3-89F2A7FE05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9EB07-91D4-47CA-83EB-E8AEF24BB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30324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473F970-79BC-818E-9920-C93B294274C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743D923-1CAA-9B05-BB9E-EDAC4EC674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B0AB36-E1B9-930F-9121-468257D45C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604DFE-CF3E-4541-8F0B-F3494D36DCC7}" type="datetimeFigureOut">
              <a:rPr lang="en-US" smtClean="0"/>
              <a:t>8/2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B6BBAF-5625-A215-33B1-1E8452B546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1BA132-7F10-7A5B-48FE-1E02BF459A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9EB07-91D4-47CA-83EB-E8AEF24BB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3158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37D824-DFE4-4D3E-5195-08F7C9DFCC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780A53-4B1F-5EF1-6B0A-335856B21FB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D63891-0C14-B5CE-5EB9-02BF0EA5AA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604DFE-CF3E-4541-8F0B-F3494D36DCC7}" type="datetimeFigureOut">
              <a:rPr lang="en-US" smtClean="0"/>
              <a:t>8/2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7269E6-9CE6-9F77-6F99-8A46832C26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051C17-B5A7-ED4E-E2AF-D63DF3D383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9EB07-91D4-47CA-83EB-E8AEF24BB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72632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57DA9F-3B0D-3463-D74F-697BB153B3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8557684-5765-43DA-A542-FFE9F581CF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CCD3D0-4E3A-EA59-60FE-2F49EF4502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604DFE-CF3E-4541-8F0B-F3494D36DCC7}" type="datetimeFigureOut">
              <a:rPr lang="en-US" smtClean="0"/>
              <a:t>8/2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DFC9D7-653F-61A3-2D79-AB83F3B8BD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CA29AC-2E39-700C-6F25-AB0FA7A497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9EB07-91D4-47CA-83EB-E8AEF24BB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05435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D48998-7FFC-C96E-76E9-53CDDEE72F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75F5E7-F658-C042-38AF-308D32A1C44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6483852-B297-1A9B-DBB0-8E3E8ED7C5E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C13ECCD-8BA8-2594-8429-804B5A56E0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604DFE-CF3E-4541-8F0B-F3494D36DCC7}" type="datetimeFigureOut">
              <a:rPr lang="en-US" smtClean="0"/>
              <a:t>8/28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9DD4DF3-E5B6-E2AB-F213-68084D53E2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27C6ECE-5502-1779-D1F2-0F35FCF275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9EB07-91D4-47CA-83EB-E8AEF24BB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4009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470306-F5A1-0743-330C-C159160CE1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2738E50-A142-DCB4-9CC0-46AEF94D24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D7C5242-4D6A-053B-FE23-C820EF55EC5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36BB0F6-6D98-AB8D-DFCE-793B41C6054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8909EB7-269F-AF9B-933A-2C3D6A44868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9EF19CF-3841-E1F8-6AE7-B37438A87A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604DFE-CF3E-4541-8F0B-F3494D36DCC7}" type="datetimeFigureOut">
              <a:rPr lang="en-US" smtClean="0"/>
              <a:t>8/28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A4CA75D-502E-0D40-9680-6C507E900A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40B12EF-F17A-8ED1-E9D7-75FF99F084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9EB07-91D4-47CA-83EB-E8AEF24BB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24250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82897E-06DC-EE7A-0325-8C0410BCC0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327CAA5-9C47-6B03-AA3D-F53FBA7577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604DFE-CF3E-4541-8F0B-F3494D36DCC7}" type="datetimeFigureOut">
              <a:rPr lang="en-US" smtClean="0"/>
              <a:t>8/28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5765EC8-0A09-6AB0-6437-A765E43C2F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8DCED03-40BF-64F5-7AE8-72B9C77EBF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9EB07-91D4-47CA-83EB-E8AEF24BB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52275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F7E448F-4A7A-D46C-E166-821F1FABD5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604DFE-CF3E-4541-8F0B-F3494D36DCC7}" type="datetimeFigureOut">
              <a:rPr lang="en-US" smtClean="0"/>
              <a:t>8/28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ACC51CC-D844-4350-196B-73DA951771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05039B6-B1B1-4B82-2948-B1FAF14DD0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9EB07-91D4-47CA-83EB-E8AEF24BB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99418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E18E02-9C88-5614-349A-3F7829A3F7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13009A9-246E-3C70-9022-4FE7BE360E5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1DA3ED1-DDD0-E12C-F1AE-4B197565E63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ECCF207-6961-CD8F-7EF7-B41B139332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604DFE-CF3E-4541-8F0B-F3494D36DCC7}" type="datetimeFigureOut">
              <a:rPr lang="en-US" smtClean="0"/>
              <a:t>8/28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0C99549-673A-CB89-E30B-CBE8D23504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CD1F699-8821-3278-06B6-DB3987DC68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9EB07-91D4-47CA-83EB-E8AEF24BB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75193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DD0BC3-EFD9-D50C-3D2D-4D82842A48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BAB60CC-8A94-2279-58DC-F0582228719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EC91797-9473-CB70-0CEE-47CF7169DA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7E718C1-FF74-90C4-2372-93A3033190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604DFE-CF3E-4541-8F0B-F3494D36DCC7}" type="datetimeFigureOut">
              <a:rPr lang="en-US" smtClean="0"/>
              <a:t>8/28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86082B6-149E-AEE7-8EBA-DC254D4E00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2E9A63B-6DC9-D624-A33D-EE3EDCC01F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9EB07-91D4-47CA-83EB-E8AEF24BB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86075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77167F9-633F-5904-993D-E7EFB82021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AB30458-06B4-D159-4CA5-B8515B57E5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4D2A78-FD98-D1CA-6B15-91AD33B8437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1604DFE-CF3E-4541-8F0B-F3494D36DCC7}" type="datetimeFigureOut">
              <a:rPr lang="en-US" smtClean="0"/>
              <a:t>8/2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13DCD9-262B-95A9-FD3E-F3E461528BB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3AF47E-DED6-BCE2-6038-63E850A1296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139EB07-91D4-47CA-83EB-E8AEF24BB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23085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1A6BB5D-D624-0075-E7C2-1EB340C4E18D}"/>
              </a:ext>
            </a:extLst>
          </p:cNvPr>
          <p:cNvSpPr txBox="1"/>
          <p:nvPr/>
        </p:nvSpPr>
        <p:spPr>
          <a:xfrm>
            <a:off x="0" y="78570"/>
            <a:ext cx="46289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ull Images – MYC Liver Gel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C7F52BE-C16E-8B50-5AA1-E2E637C44AA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82" t="2816"/>
          <a:stretch/>
        </p:blipFill>
        <p:spPr>
          <a:xfrm>
            <a:off x="1326640" y="2087631"/>
            <a:ext cx="4826288" cy="2910126"/>
          </a:xfrm>
          <a:prstGeom prst="rect">
            <a:avLst/>
          </a:prstGeom>
        </p:spPr>
      </p:pic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849D5EDD-80BA-14B6-4EE1-024D75B047C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18200531"/>
              </p:ext>
            </p:extLst>
          </p:nvPr>
        </p:nvGraphicFramePr>
        <p:xfrm>
          <a:off x="2314464" y="4997757"/>
          <a:ext cx="3615845" cy="13106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57627">
                  <a:extLst>
                    <a:ext uri="{9D8B030D-6E8A-4147-A177-3AD203B41FA5}">
                      <a16:colId xmlns:a16="http://schemas.microsoft.com/office/drawing/2014/main" val="2205148410"/>
                    </a:ext>
                  </a:extLst>
                </a:gridCol>
                <a:gridCol w="247774">
                  <a:extLst>
                    <a:ext uri="{9D8B030D-6E8A-4147-A177-3AD203B41FA5}">
                      <a16:colId xmlns:a16="http://schemas.microsoft.com/office/drawing/2014/main" val="3482611889"/>
                    </a:ext>
                  </a:extLst>
                </a:gridCol>
                <a:gridCol w="273960">
                  <a:extLst>
                    <a:ext uri="{9D8B030D-6E8A-4147-A177-3AD203B41FA5}">
                      <a16:colId xmlns:a16="http://schemas.microsoft.com/office/drawing/2014/main" val="4086795594"/>
                    </a:ext>
                  </a:extLst>
                </a:gridCol>
                <a:gridCol w="230767">
                  <a:extLst>
                    <a:ext uri="{9D8B030D-6E8A-4147-A177-3AD203B41FA5}">
                      <a16:colId xmlns:a16="http://schemas.microsoft.com/office/drawing/2014/main" val="3120218870"/>
                    </a:ext>
                  </a:extLst>
                </a:gridCol>
                <a:gridCol w="240801">
                  <a:extLst>
                    <a:ext uri="{9D8B030D-6E8A-4147-A177-3AD203B41FA5}">
                      <a16:colId xmlns:a16="http://schemas.microsoft.com/office/drawing/2014/main" val="1326411608"/>
                    </a:ext>
                  </a:extLst>
                </a:gridCol>
                <a:gridCol w="250835">
                  <a:extLst>
                    <a:ext uri="{9D8B030D-6E8A-4147-A177-3AD203B41FA5}">
                      <a16:colId xmlns:a16="http://schemas.microsoft.com/office/drawing/2014/main" val="3603901303"/>
                    </a:ext>
                  </a:extLst>
                </a:gridCol>
                <a:gridCol w="280934">
                  <a:extLst>
                    <a:ext uri="{9D8B030D-6E8A-4147-A177-3AD203B41FA5}">
                      <a16:colId xmlns:a16="http://schemas.microsoft.com/office/drawing/2014/main" val="2439394057"/>
                    </a:ext>
                  </a:extLst>
                </a:gridCol>
                <a:gridCol w="213039">
                  <a:extLst>
                    <a:ext uri="{9D8B030D-6E8A-4147-A177-3AD203B41FA5}">
                      <a16:colId xmlns:a16="http://schemas.microsoft.com/office/drawing/2014/main" val="4252921326"/>
                    </a:ext>
                  </a:extLst>
                </a:gridCol>
                <a:gridCol w="279400">
                  <a:extLst>
                    <a:ext uri="{9D8B030D-6E8A-4147-A177-3AD203B41FA5}">
                      <a16:colId xmlns:a16="http://schemas.microsoft.com/office/drawing/2014/main" val="17075094"/>
                    </a:ext>
                  </a:extLst>
                </a:gridCol>
                <a:gridCol w="242191">
                  <a:extLst>
                    <a:ext uri="{9D8B030D-6E8A-4147-A177-3AD203B41FA5}">
                      <a16:colId xmlns:a16="http://schemas.microsoft.com/office/drawing/2014/main" val="2003185267"/>
                    </a:ext>
                  </a:extLst>
                </a:gridCol>
                <a:gridCol w="254284">
                  <a:extLst>
                    <a:ext uri="{9D8B030D-6E8A-4147-A177-3AD203B41FA5}">
                      <a16:colId xmlns:a16="http://schemas.microsoft.com/office/drawing/2014/main" val="1976185737"/>
                    </a:ext>
                  </a:extLst>
                </a:gridCol>
                <a:gridCol w="314084">
                  <a:extLst>
                    <a:ext uri="{9D8B030D-6E8A-4147-A177-3AD203B41FA5}">
                      <a16:colId xmlns:a16="http://schemas.microsoft.com/office/drawing/2014/main" val="1850759503"/>
                    </a:ext>
                  </a:extLst>
                </a:gridCol>
                <a:gridCol w="307818">
                  <a:extLst>
                    <a:ext uri="{9D8B030D-6E8A-4147-A177-3AD203B41FA5}">
                      <a16:colId xmlns:a16="http://schemas.microsoft.com/office/drawing/2014/main" val="616470695"/>
                    </a:ext>
                  </a:extLst>
                </a:gridCol>
                <a:gridCol w="222331">
                  <a:extLst>
                    <a:ext uri="{9D8B030D-6E8A-4147-A177-3AD203B41FA5}">
                      <a16:colId xmlns:a16="http://schemas.microsoft.com/office/drawing/2014/main" val="857618006"/>
                    </a:ext>
                  </a:extLst>
                </a:gridCol>
              </a:tblGrid>
              <a:tr h="1215428"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VER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VER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</a:t>
                      </a: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R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VER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VER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VER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</a:t>
                      </a: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R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VER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</a:t>
                      </a: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R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S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 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S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</a:t>
                      </a:r>
                      <a:b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61908030"/>
                  </a:ext>
                </a:extLst>
              </a:tr>
            </a:tbl>
          </a:graphicData>
        </a:graphic>
      </p:graphicFrame>
      <p:pic>
        <p:nvPicPr>
          <p:cNvPr id="12" name="Picture 11">
            <a:extLst>
              <a:ext uri="{FF2B5EF4-FFF2-40B4-BE49-F238E27FC236}">
                <a16:creationId xmlns:a16="http://schemas.microsoft.com/office/drawing/2014/main" id="{55017A80-B845-6FA7-3AB7-9FB468F9BAD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649" t="23630" r="55148" b="36106"/>
          <a:stretch/>
        </p:blipFill>
        <p:spPr>
          <a:xfrm>
            <a:off x="6481491" y="2094254"/>
            <a:ext cx="4826288" cy="2903503"/>
          </a:xfrm>
          <a:prstGeom prst="rect">
            <a:avLst/>
          </a:prstGeom>
        </p:spPr>
      </p:pic>
      <p:graphicFrame>
        <p:nvGraphicFramePr>
          <p:cNvPr id="13" name="Table 12">
            <a:extLst>
              <a:ext uri="{FF2B5EF4-FFF2-40B4-BE49-F238E27FC236}">
                <a16:creationId xmlns:a16="http://schemas.microsoft.com/office/drawing/2014/main" id="{CEC254D7-9DED-D815-D922-754188F8033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30251862"/>
              </p:ext>
            </p:extLst>
          </p:nvPr>
        </p:nvGraphicFramePr>
        <p:xfrm>
          <a:off x="7550590" y="4997757"/>
          <a:ext cx="3761610" cy="13106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67698">
                  <a:extLst>
                    <a:ext uri="{9D8B030D-6E8A-4147-A177-3AD203B41FA5}">
                      <a16:colId xmlns:a16="http://schemas.microsoft.com/office/drawing/2014/main" val="2205148410"/>
                    </a:ext>
                  </a:extLst>
                </a:gridCol>
                <a:gridCol w="257460">
                  <a:extLst>
                    <a:ext uri="{9D8B030D-6E8A-4147-A177-3AD203B41FA5}">
                      <a16:colId xmlns:a16="http://schemas.microsoft.com/office/drawing/2014/main" val="3482611889"/>
                    </a:ext>
                  </a:extLst>
                </a:gridCol>
                <a:gridCol w="284669">
                  <a:extLst>
                    <a:ext uri="{9D8B030D-6E8A-4147-A177-3AD203B41FA5}">
                      <a16:colId xmlns:a16="http://schemas.microsoft.com/office/drawing/2014/main" val="4086795594"/>
                    </a:ext>
                  </a:extLst>
                </a:gridCol>
                <a:gridCol w="239787">
                  <a:extLst>
                    <a:ext uri="{9D8B030D-6E8A-4147-A177-3AD203B41FA5}">
                      <a16:colId xmlns:a16="http://schemas.microsoft.com/office/drawing/2014/main" val="3120218870"/>
                    </a:ext>
                  </a:extLst>
                </a:gridCol>
                <a:gridCol w="250214">
                  <a:extLst>
                    <a:ext uri="{9D8B030D-6E8A-4147-A177-3AD203B41FA5}">
                      <a16:colId xmlns:a16="http://schemas.microsoft.com/office/drawing/2014/main" val="1326411608"/>
                    </a:ext>
                  </a:extLst>
                </a:gridCol>
                <a:gridCol w="260640">
                  <a:extLst>
                    <a:ext uri="{9D8B030D-6E8A-4147-A177-3AD203B41FA5}">
                      <a16:colId xmlns:a16="http://schemas.microsoft.com/office/drawing/2014/main" val="3603901303"/>
                    </a:ext>
                  </a:extLst>
                </a:gridCol>
                <a:gridCol w="291916">
                  <a:extLst>
                    <a:ext uri="{9D8B030D-6E8A-4147-A177-3AD203B41FA5}">
                      <a16:colId xmlns:a16="http://schemas.microsoft.com/office/drawing/2014/main" val="2439394057"/>
                    </a:ext>
                  </a:extLst>
                </a:gridCol>
                <a:gridCol w="221367">
                  <a:extLst>
                    <a:ext uri="{9D8B030D-6E8A-4147-A177-3AD203B41FA5}">
                      <a16:colId xmlns:a16="http://schemas.microsoft.com/office/drawing/2014/main" val="4252921326"/>
                    </a:ext>
                  </a:extLst>
                </a:gridCol>
                <a:gridCol w="292216">
                  <a:extLst>
                    <a:ext uri="{9D8B030D-6E8A-4147-A177-3AD203B41FA5}">
                      <a16:colId xmlns:a16="http://schemas.microsoft.com/office/drawing/2014/main" val="17075094"/>
                    </a:ext>
                  </a:extLst>
                </a:gridCol>
                <a:gridCol w="301284">
                  <a:extLst>
                    <a:ext uri="{9D8B030D-6E8A-4147-A177-3AD203B41FA5}">
                      <a16:colId xmlns:a16="http://schemas.microsoft.com/office/drawing/2014/main" val="2003185267"/>
                    </a:ext>
                  </a:extLst>
                </a:gridCol>
                <a:gridCol w="265790">
                  <a:extLst>
                    <a:ext uri="{9D8B030D-6E8A-4147-A177-3AD203B41FA5}">
                      <a16:colId xmlns:a16="http://schemas.microsoft.com/office/drawing/2014/main" val="1976185737"/>
                    </a:ext>
                  </a:extLst>
                </a:gridCol>
                <a:gridCol w="208280">
                  <a:extLst>
                    <a:ext uri="{9D8B030D-6E8A-4147-A177-3AD203B41FA5}">
                      <a16:colId xmlns:a16="http://schemas.microsoft.com/office/drawing/2014/main" val="1850759503"/>
                    </a:ext>
                  </a:extLst>
                </a:gridCol>
                <a:gridCol w="389267">
                  <a:extLst>
                    <a:ext uri="{9D8B030D-6E8A-4147-A177-3AD203B41FA5}">
                      <a16:colId xmlns:a16="http://schemas.microsoft.com/office/drawing/2014/main" val="616470695"/>
                    </a:ext>
                  </a:extLst>
                </a:gridCol>
                <a:gridCol w="231022">
                  <a:extLst>
                    <a:ext uri="{9D8B030D-6E8A-4147-A177-3AD203B41FA5}">
                      <a16:colId xmlns:a16="http://schemas.microsoft.com/office/drawing/2014/main" val="857618006"/>
                    </a:ext>
                  </a:extLst>
                </a:gridCol>
              </a:tblGrid>
              <a:tr h="1215428"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VER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VER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</a:t>
                      </a: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R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VER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VER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VER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</a:t>
                      </a: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R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VER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</a:t>
                      </a: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R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S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 </a:t>
                      </a:r>
                    </a:p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</a:t>
                      </a: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</a:t>
                      </a:r>
                    </a:p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61908030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95E4AF9F-086F-94E7-4117-D52DB1F66290}"/>
              </a:ext>
            </a:extLst>
          </p:cNvPr>
          <p:cNvSpPr txBox="1"/>
          <p:nvPr/>
        </p:nvSpPr>
        <p:spPr>
          <a:xfrm>
            <a:off x="8930739" y="273170"/>
            <a:ext cx="3073193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CON=Control</a:t>
            </a:r>
            <a:br>
              <a:rPr lang="en-US" sz="1100" dirty="0"/>
            </a:br>
            <a:r>
              <a:rPr lang="en-US" sz="1100" dirty="0"/>
              <a:t>GAS=Gastrocnemius</a:t>
            </a:r>
          </a:p>
          <a:p>
            <a:r>
              <a:rPr lang="en-US" sz="1100" dirty="0"/>
              <a:t>IC=Internal control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3FF033B-188A-D7BE-D667-A15F379DF344}"/>
              </a:ext>
            </a:extLst>
          </p:cNvPr>
          <p:cNvSpPr txBox="1"/>
          <p:nvPr/>
        </p:nvSpPr>
        <p:spPr>
          <a:xfrm>
            <a:off x="564853" y="2094253"/>
            <a:ext cx="11950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0070C0"/>
                </a:solidFill>
              </a:rPr>
              <a:t>250 </a:t>
            </a:r>
            <a:r>
              <a:rPr lang="en-US" sz="1100" dirty="0" err="1">
                <a:solidFill>
                  <a:srgbClr val="0070C0"/>
                </a:solidFill>
              </a:rPr>
              <a:t>kDa</a:t>
            </a:r>
            <a:endParaRPr lang="en-US" sz="1100" dirty="0">
              <a:solidFill>
                <a:srgbClr val="0070C0"/>
              </a:solidFill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501A7EE-A283-9EBD-2A91-BC151E2BF8CC}"/>
              </a:ext>
            </a:extLst>
          </p:cNvPr>
          <p:cNvSpPr txBox="1"/>
          <p:nvPr/>
        </p:nvSpPr>
        <p:spPr>
          <a:xfrm>
            <a:off x="564853" y="2298534"/>
            <a:ext cx="11950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0070C0"/>
                </a:solidFill>
              </a:rPr>
              <a:t>150 </a:t>
            </a:r>
            <a:r>
              <a:rPr lang="en-US" sz="1100" dirty="0" err="1">
                <a:solidFill>
                  <a:srgbClr val="0070C0"/>
                </a:solidFill>
              </a:rPr>
              <a:t>kDa</a:t>
            </a:r>
            <a:endParaRPr lang="en-US" sz="1100" dirty="0">
              <a:solidFill>
                <a:srgbClr val="0070C0"/>
              </a:solidFill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07F8377-271F-9DAA-975D-B1B0E8254FDB}"/>
              </a:ext>
            </a:extLst>
          </p:cNvPr>
          <p:cNvSpPr txBox="1"/>
          <p:nvPr/>
        </p:nvSpPr>
        <p:spPr>
          <a:xfrm>
            <a:off x="564853" y="2502815"/>
            <a:ext cx="11950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0070C0"/>
                </a:solidFill>
              </a:rPr>
              <a:t>100 </a:t>
            </a:r>
            <a:r>
              <a:rPr lang="en-US" sz="1100" dirty="0" err="1">
                <a:solidFill>
                  <a:srgbClr val="0070C0"/>
                </a:solidFill>
              </a:rPr>
              <a:t>kDa</a:t>
            </a:r>
            <a:endParaRPr lang="en-US" sz="1100" dirty="0">
              <a:solidFill>
                <a:srgbClr val="0070C0"/>
              </a:solidFill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98932B6-F445-5DFD-8D11-3F36D5A9EAEF}"/>
              </a:ext>
            </a:extLst>
          </p:cNvPr>
          <p:cNvSpPr txBox="1"/>
          <p:nvPr/>
        </p:nvSpPr>
        <p:spPr>
          <a:xfrm>
            <a:off x="564853" y="3098928"/>
            <a:ext cx="11950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0070C0"/>
                </a:solidFill>
              </a:rPr>
              <a:t>50 </a:t>
            </a:r>
            <a:r>
              <a:rPr lang="en-US" sz="1100" dirty="0" err="1">
                <a:solidFill>
                  <a:srgbClr val="0070C0"/>
                </a:solidFill>
              </a:rPr>
              <a:t>kDa</a:t>
            </a:r>
            <a:endParaRPr lang="en-US" sz="1100" dirty="0">
              <a:solidFill>
                <a:srgbClr val="0070C0"/>
              </a:solidFill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201498B-7A9A-1A73-F782-E6F581329476}"/>
              </a:ext>
            </a:extLst>
          </p:cNvPr>
          <p:cNvSpPr txBox="1"/>
          <p:nvPr/>
        </p:nvSpPr>
        <p:spPr>
          <a:xfrm>
            <a:off x="564853" y="2644273"/>
            <a:ext cx="11950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FF40FF"/>
                </a:solidFill>
              </a:rPr>
              <a:t>75 </a:t>
            </a:r>
            <a:r>
              <a:rPr lang="en-US" sz="1100" dirty="0" err="1">
                <a:solidFill>
                  <a:srgbClr val="FF40FF"/>
                </a:solidFill>
              </a:rPr>
              <a:t>kDa</a:t>
            </a:r>
            <a:endParaRPr lang="en-US" sz="1100" dirty="0">
              <a:solidFill>
                <a:srgbClr val="FF40FF"/>
              </a:solidFill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625D006-F327-99AF-C225-E257D3B47C32}"/>
              </a:ext>
            </a:extLst>
          </p:cNvPr>
          <p:cNvSpPr txBox="1"/>
          <p:nvPr/>
        </p:nvSpPr>
        <p:spPr>
          <a:xfrm>
            <a:off x="564853" y="3570057"/>
            <a:ext cx="11950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0070C0"/>
                </a:solidFill>
              </a:rPr>
              <a:t>37 </a:t>
            </a:r>
            <a:r>
              <a:rPr lang="en-US" sz="1100" dirty="0" err="1">
                <a:solidFill>
                  <a:srgbClr val="0070C0"/>
                </a:solidFill>
              </a:rPr>
              <a:t>kDa</a:t>
            </a:r>
            <a:endParaRPr lang="en-US" sz="1100" dirty="0">
              <a:solidFill>
                <a:srgbClr val="0070C0"/>
              </a:solidFill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348DB5D-A597-63C7-BE88-B8D1958A0842}"/>
              </a:ext>
            </a:extLst>
          </p:cNvPr>
          <p:cNvSpPr txBox="1"/>
          <p:nvPr/>
        </p:nvSpPr>
        <p:spPr>
          <a:xfrm>
            <a:off x="564853" y="4253897"/>
            <a:ext cx="11950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FF40FF"/>
                </a:solidFill>
              </a:rPr>
              <a:t>25 </a:t>
            </a:r>
            <a:r>
              <a:rPr lang="en-US" sz="1100" dirty="0" err="1">
                <a:solidFill>
                  <a:srgbClr val="FF40FF"/>
                </a:solidFill>
              </a:rPr>
              <a:t>kDa</a:t>
            </a:r>
            <a:endParaRPr lang="en-US" sz="1100" dirty="0">
              <a:solidFill>
                <a:srgbClr val="FF40FF"/>
              </a:solidFill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DBBCFFD-CFDB-D0E6-2C47-BC621F0C4E1F}"/>
              </a:ext>
            </a:extLst>
          </p:cNvPr>
          <p:cNvSpPr txBox="1"/>
          <p:nvPr/>
        </p:nvSpPr>
        <p:spPr>
          <a:xfrm>
            <a:off x="564853" y="4515507"/>
            <a:ext cx="11950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0070C0"/>
                </a:solidFill>
              </a:rPr>
              <a:t>20 </a:t>
            </a:r>
            <a:r>
              <a:rPr lang="en-US" sz="1100" dirty="0" err="1">
                <a:solidFill>
                  <a:srgbClr val="0070C0"/>
                </a:solidFill>
              </a:rPr>
              <a:t>kDa</a:t>
            </a:r>
            <a:endParaRPr lang="en-US" sz="1100" dirty="0">
              <a:solidFill>
                <a:srgbClr val="0070C0"/>
              </a:solidFill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4ED54E73-C8E0-9D9C-73CD-184A1EF44742}"/>
              </a:ext>
            </a:extLst>
          </p:cNvPr>
          <p:cNvSpPr/>
          <p:nvPr/>
        </p:nvSpPr>
        <p:spPr>
          <a:xfrm rot="180000">
            <a:off x="3767847" y="3300920"/>
            <a:ext cx="1387814" cy="744530"/>
          </a:xfrm>
          <a:prstGeom prst="rect">
            <a:avLst/>
          </a:prstGeom>
          <a:noFill/>
          <a:ln/>
        </p:spPr>
        <p:style>
          <a:lnRef idx="2">
            <a:schemeClr val="accent4"/>
          </a:lnRef>
          <a:fillRef idx="1">
            <a:schemeClr val="lt1"/>
          </a:fillRef>
          <a:effectRef idx="0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6D942816-2870-25DC-97B2-67769E2FF7DC}"/>
              </a:ext>
            </a:extLst>
          </p:cNvPr>
          <p:cNvSpPr/>
          <p:nvPr/>
        </p:nvSpPr>
        <p:spPr>
          <a:xfrm rot="120000">
            <a:off x="9073036" y="3098928"/>
            <a:ext cx="1387814" cy="37708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31708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4</TotalTime>
  <Words>114</Words>
  <Application>Microsoft Macintosh PowerPoint</Application>
  <PresentationFormat>Widescreen</PresentationFormat>
  <Paragraphs>11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bin Khadgi</dc:creator>
  <cp:lastModifiedBy>Sebastian Edman</cp:lastModifiedBy>
  <cp:revision>16</cp:revision>
  <dcterms:created xsi:type="dcterms:W3CDTF">2024-03-15T18:36:29Z</dcterms:created>
  <dcterms:modified xsi:type="dcterms:W3CDTF">2024-08-28T11:19:53Z</dcterms:modified>
</cp:coreProperties>
</file>